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57" r:id="rId3"/>
    <p:sldId id="262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7FDB98-09F8-4206-9F71-A89A35D8BC5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965E7B-0E70-4E5A-A09E-A62F22718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4210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: On target effects of ASTX660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Western Blot analysis of cIAP1, cIAP2 and XIAP expression following treatment with 10µM, 1µM, 100nM, 10nM and 1nM ASTX660 for 24h.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Western Blot analysis of cIAP1, cIAP2, and XIAP expression following 1, 3, 6, 12 and 24 hour treatment with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clinically-achievable dose of 1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ASTX660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Western blot analysis of RIPK1 and caspase-8 following caspase-8 immunoprecipitation in cells treated for 3 hours with 1µM ASTX660 in the presence and absence of 10 ng/ mL TNFα; cells were pretreated with 20µM z-VAD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mk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Cell viability assay of PC3, DU145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Ca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treated for 72 hours with 10nM, 100nM, 1μM or 10μM in the presence and absence of 10 ng/ mL TNFα.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715735-585C-46BB-8A2C-973CAFE400A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7577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: FLIP siRNA sensitises to ASTX660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pidiu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odide flow cytometry analysis of PC3 and DU145 cells treated for 24 hours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 10nM SC or FT siRNA followed by 24 hours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 1µM ASTX660 in the presence and absence of 10 ng/ mL TNFα .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ell viability assay of cells treated for 24h with 10nM SC or FT siRNA followed by 72h with 1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ASTX660 alone or in combination with 10ng/mL TNF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715735-585C-46BB-8A2C-973CAFE400A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5022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: 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uantitative RT-PCR analysis of FLIP(L) and FLIP(S) RNA expression in PC3 and DU145 cells following 24 hours treatment with 1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tinosta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Values presented as delta-delta (ΔΔ)CT ratio normalized to RPL24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usekeeking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.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715735-585C-46BB-8A2C-973CAFE400A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34227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: </a:t>
            </a:r>
            <a:r>
              <a:rPr lang="en-IE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tinostat</a:t>
            </a:r>
            <a:r>
              <a:rPr lang="en-IE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nsitises to ASTX660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exin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/PI flow cytometry analysis of PC3, DU145 cells upon 24 hours pre-treatment with 1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tinostat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llowed by 24 hours with ASTX660 +/- TNF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Cell Titre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o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 viability assay following 24 hours pre-treatment with 0, 0.1, 0.5, 1.0 and 2.5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tinostat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llowed by 48 hours with ASTX660+TNF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715735-585C-46BB-8A2C-973CAFE400A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7550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671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141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01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871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6860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3858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3101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787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516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7308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7061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5DA4D-F10A-4894-BF46-4AA7D8BC738F}" type="datetimeFigureOut">
              <a:rPr lang="en-GB" smtClean="0"/>
              <a:t>19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D4EFA-7072-4B94-B0C1-2C2F8F578C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440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5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8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0" Type="http://schemas.openxmlformats.org/officeDocument/2006/relationships/oleObject" Target="../embeddings/oleObject10.bin"/><Relationship Id="rId4" Type="http://schemas.openxmlformats.org/officeDocument/2006/relationships/oleObject" Target="../embeddings/oleObject7.bin"/><Relationship Id="rId9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1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12.bin"/><Relationship Id="rId5" Type="http://schemas.openxmlformats.org/officeDocument/2006/relationships/image" Target="../media/image13.emf"/><Relationship Id="rId4" Type="http://schemas.openxmlformats.org/officeDocument/2006/relationships/oleObject" Target="../embeddings/oleObject11.bin"/><Relationship Id="rId9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05537" y="263390"/>
            <a:ext cx="2507931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GB" b="1" dirty="0"/>
              <a:t>Supplementary Figure 1</a:t>
            </a:r>
            <a:r>
              <a:rPr lang="en-GB" b="1" dirty="0" smtClean="0"/>
              <a:t> </a:t>
            </a:r>
            <a:endParaRPr lang="en-GB" b="1" dirty="0"/>
          </a:p>
          <a:p>
            <a:endParaRPr lang="en-GB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6070913"/>
              </p:ext>
            </p:extLst>
          </p:nvPr>
        </p:nvGraphicFramePr>
        <p:xfrm>
          <a:off x="1998663" y="1216025"/>
          <a:ext cx="3322637" cy="325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8" name="Prism 5" r:id="rId3" imgW="3488760" imgH="3386520" progId="Prism5.Document">
                  <p:embed/>
                </p:oleObj>
              </mc:Choice>
              <mc:Fallback>
                <p:oleObj name="Prism 5" r:id="rId3" imgW="3488760" imgH="33865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98663" y="1216025"/>
                        <a:ext cx="3322637" cy="325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9277008"/>
              </p:ext>
            </p:extLst>
          </p:nvPr>
        </p:nvGraphicFramePr>
        <p:xfrm>
          <a:off x="6637338" y="1216025"/>
          <a:ext cx="3248025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9" name="Prism 5" r:id="rId5" imgW="3927240" imgH="2917080" progId="Prism5.Document">
                  <p:embed/>
                </p:oleObj>
              </mc:Choice>
              <mc:Fallback>
                <p:oleObj name="Prism 5" r:id="rId5" imgW="3927240" imgH="29170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37338" y="1216025"/>
                        <a:ext cx="3248025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224588" y="1322355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1770063" y="1322355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85263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534887" y="52235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2</a:t>
            </a:r>
            <a:endParaRPr lang="en-GB" b="1" dirty="0"/>
          </a:p>
        </p:txBody>
      </p:sp>
      <p:grpSp>
        <p:nvGrpSpPr>
          <p:cNvPr id="138" name="Group 137"/>
          <p:cNvGrpSpPr/>
          <p:nvPr/>
        </p:nvGrpSpPr>
        <p:grpSpPr>
          <a:xfrm>
            <a:off x="2096866" y="669776"/>
            <a:ext cx="2843434" cy="1668545"/>
            <a:chOff x="661766" y="2370055"/>
            <a:chExt cx="2843434" cy="1668545"/>
          </a:xfrm>
        </p:grpSpPr>
        <p:grpSp>
          <p:nvGrpSpPr>
            <p:cNvPr id="98" name="Group 97"/>
            <p:cNvGrpSpPr/>
            <p:nvPr/>
          </p:nvGrpSpPr>
          <p:grpSpPr>
            <a:xfrm>
              <a:off x="2645273" y="3486371"/>
              <a:ext cx="859927" cy="552229"/>
              <a:chOff x="8337124" y="1586222"/>
              <a:chExt cx="859927" cy="490025"/>
            </a:xfrm>
          </p:grpSpPr>
          <p:cxnSp>
            <p:nvCxnSpPr>
              <p:cNvPr id="99" name="Straight Connector 98"/>
              <p:cNvCxnSpPr/>
              <p:nvPr/>
            </p:nvCxnSpPr>
            <p:spPr>
              <a:xfrm flipV="1">
                <a:off x="8363811" y="1586222"/>
                <a:ext cx="0" cy="4900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TextBox 99"/>
              <p:cNvSpPr txBox="1">
                <a:spLocks noChangeArrowheads="1"/>
              </p:cNvSpPr>
              <p:nvPr/>
            </p:nvSpPr>
            <p:spPr bwMode="auto">
              <a:xfrm>
                <a:off x="8337124" y="1595643"/>
                <a:ext cx="707527" cy="204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IB: RIPK1</a:t>
                </a:r>
                <a:endParaRPr lang="en-GB" sz="900" dirty="0"/>
              </a:p>
            </p:txBody>
          </p:sp>
          <p:sp>
            <p:nvSpPr>
              <p:cNvPr id="101" name="TextBox 100"/>
              <p:cNvSpPr txBox="1">
                <a:spLocks noChangeArrowheads="1"/>
              </p:cNvSpPr>
              <p:nvPr/>
            </p:nvSpPr>
            <p:spPr bwMode="auto">
              <a:xfrm>
                <a:off x="8337124" y="1825549"/>
                <a:ext cx="859927" cy="204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IB: Caspase-8</a:t>
                </a:r>
                <a:endParaRPr lang="en-GB" sz="900" dirty="0"/>
              </a:p>
            </p:txBody>
          </p:sp>
        </p:grpSp>
        <p:sp>
          <p:nvSpPr>
            <p:cNvPr id="102" name="TextBox 101"/>
            <p:cNvSpPr txBox="1"/>
            <p:nvPr/>
          </p:nvSpPr>
          <p:spPr>
            <a:xfrm>
              <a:off x="1123568" y="2370055"/>
              <a:ext cx="7636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u="sng" dirty="0"/>
                <a:t>PC3</a:t>
              </a: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668015" y="2502727"/>
              <a:ext cx="1955531" cy="978918"/>
              <a:chOff x="313484" y="245874"/>
              <a:chExt cx="1955531" cy="978918"/>
            </a:xfrm>
          </p:grpSpPr>
          <p:sp>
            <p:nvSpPr>
              <p:cNvPr id="104" name="TextBox 103"/>
              <p:cNvSpPr txBox="1">
                <a:spLocks noChangeArrowheads="1"/>
              </p:cNvSpPr>
              <p:nvPr/>
            </p:nvSpPr>
            <p:spPr bwMode="auto">
              <a:xfrm rot="16200000">
                <a:off x="151102" y="831578"/>
                <a:ext cx="5555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Lysate</a:t>
                </a:r>
              </a:p>
            </p:txBody>
          </p:sp>
          <p:sp>
            <p:nvSpPr>
              <p:cNvPr id="105" name="TextBox 104"/>
              <p:cNvSpPr txBox="1">
                <a:spLocks noChangeArrowheads="1"/>
              </p:cNvSpPr>
              <p:nvPr/>
            </p:nvSpPr>
            <p:spPr bwMode="auto">
              <a:xfrm rot="16200000">
                <a:off x="155028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06" name="TextBox 105"/>
              <p:cNvSpPr txBox="1">
                <a:spLocks noChangeArrowheads="1"/>
              </p:cNvSpPr>
              <p:nvPr/>
            </p:nvSpPr>
            <p:spPr bwMode="auto">
              <a:xfrm rot="16200000">
                <a:off x="1086860" y="689401"/>
                <a:ext cx="8399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660</a:t>
                </a:r>
                <a:endParaRPr lang="en-GB" sz="900" dirty="0"/>
              </a:p>
            </p:txBody>
          </p:sp>
          <p:sp>
            <p:nvSpPr>
              <p:cNvPr id="107" name="TextBox 106"/>
              <p:cNvSpPr txBox="1">
                <a:spLocks noChangeArrowheads="1"/>
              </p:cNvSpPr>
              <p:nvPr/>
            </p:nvSpPr>
            <p:spPr bwMode="auto">
              <a:xfrm rot="16200000">
                <a:off x="1472086" y="643453"/>
                <a:ext cx="9318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08" name="TextBox 107"/>
              <p:cNvSpPr txBox="1">
                <a:spLocks noChangeArrowheads="1"/>
              </p:cNvSpPr>
              <p:nvPr/>
            </p:nvSpPr>
            <p:spPr bwMode="auto">
              <a:xfrm rot="16200000">
                <a:off x="370615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09" name="TextBox 108"/>
              <p:cNvSpPr txBox="1">
                <a:spLocks noChangeArrowheads="1"/>
              </p:cNvSpPr>
              <p:nvPr/>
            </p:nvSpPr>
            <p:spPr bwMode="auto">
              <a:xfrm rot="16200000">
                <a:off x="586202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Con</a:t>
                </a:r>
                <a:endParaRPr lang="en-GB" sz="900" dirty="0"/>
              </a:p>
            </p:txBody>
          </p:sp>
          <p:sp>
            <p:nvSpPr>
              <p:cNvPr id="110" name="TextBox 109"/>
              <p:cNvSpPr txBox="1">
                <a:spLocks noChangeArrowheads="1"/>
              </p:cNvSpPr>
              <p:nvPr/>
            </p:nvSpPr>
            <p:spPr bwMode="auto">
              <a:xfrm rot="16200000">
                <a:off x="1302447" y="689401"/>
                <a:ext cx="8399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32711</a:t>
                </a:r>
                <a:endParaRPr lang="en-GB" sz="900" dirty="0"/>
              </a:p>
            </p:txBody>
          </p:sp>
          <p:sp>
            <p:nvSpPr>
              <p:cNvPr id="111" name="TextBox 110"/>
              <p:cNvSpPr txBox="1">
                <a:spLocks noChangeArrowheads="1"/>
              </p:cNvSpPr>
              <p:nvPr/>
            </p:nvSpPr>
            <p:spPr bwMode="auto">
              <a:xfrm rot="16200000">
                <a:off x="1687676" y="643453"/>
                <a:ext cx="9318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12" name="TextBox 111"/>
              <p:cNvSpPr txBox="1">
                <a:spLocks noChangeArrowheads="1"/>
              </p:cNvSpPr>
              <p:nvPr/>
            </p:nvSpPr>
            <p:spPr bwMode="auto">
              <a:xfrm rot="16200000">
                <a:off x="801789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</p:grpSp>
        <p:cxnSp>
          <p:nvCxnSpPr>
            <p:cNvPr id="113" name="Straight Connector 112"/>
            <p:cNvCxnSpPr/>
            <p:nvPr/>
          </p:nvCxnSpPr>
          <p:spPr>
            <a:xfrm>
              <a:off x="887008" y="2767220"/>
              <a:ext cx="399656" cy="8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>
              <a:spLocks noChangeArrowheads="1"/>
            </p:cNvSpPr>
            <p:nvPr/>
          </p:nvSpPr>
          <p:spPr bwMode="auto">
            <a:xfrm>
              <a:off x="856106" y="2547392"/>
              <a:ext cx="510151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sz="900" b="1" dirty="0"/>
                <a:t>IP: IgG</a:t>
              </a:r>
              <a:endParaRPr lang="en-GB" sz="900" dirty="0"/>
            </a:p>
          </p:txBody>
        </p:sp>
        <p:cxnSp>
          <p:nvCxnSpPr>
            <p:cNvPr id="115" name="Straight Connector 114"/>
            <p:cNvCxnSpPr/>
            <p:nvPr/>
          </p:nvCxnSpPr>
          <p:spPr>
            <a:xfrm>
              <a:off x="1432749" y="2766397"/>
              <a:ext cx="1140266" cy="8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/>
            <p:cNvSpPr txBox="1">
              <a:spLocks noChangeArrowheads="1"/>
            </p:cNvSpPr>
            <p:nvPr/>
          </p:nvSpPr>
          <p:spPr bwMode="auto">
            <a:xfrm>
              <a:off x="1658615" y="2547037"/>
              <a:ext cx="64658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sz="900" b="1" dirty="0"/>
                <a:t>IP: Casp8</a:t>
              </a:r>
              <a:endParaRPr lang="en-GB" sz="900" dirty="0"/>
            </a:p>
          </p:txBody>
        </p:sp>
        <p:pic>
          <p:nvPicPr>
            <p:cNvPr id="117" name="Picture 1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1766" y="3485429"/>
              <a:ext cx="1987449" cy="541297"/>
            </a:xfrm>
            <a:prstGeom prst="rect">
              <a:avLst/>
            </a:prstGeom>
          </p:spPr>
        </p:pic>
      </p:grpSp>
      <p:grpSp>
        <p:nvGrpSpPr>
          <p:cNvPr id="140" name="Group 139"/>
          <p:cNvGrpSpPr/>
          <p:nvPr/>
        </p:nvGrpSpPr>
        <p:grpSpPr>
          <a:xfrm>
            <a:off x="5263477" y="664259"/>
            <a:ext cx="2825058" cy="1668545"/>
            <a:chOff x="3828376" y="2364538"/>
            <a:chExt cx="2825058" cy="1668545"/>
          </a:xfrm>
        </p:grpSpPr>
        <p:grpSp>
          <p:nvGrpSpPr>
            <p:cNvPr id="118" name="Group 117"/>
            <p:cNvGrpSpPr/>
            <p:nvPr/>
          </p:nvGrpSpPr>
          <p:grpSpPr>
            <a:xfrm>
              <a:off x="5793507" y="3480854"/>
              <a:ext cx="859927" cy="552229"/>
              <a:chOff x="8337124" y="1586222"/>
              <a:chExt cx="859927" cy="490025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 flipV="1">
                <a:off x="8363811" y="1586222"/>
                <a:ext cx="0" cy="4900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119"/>
              <p:cNvSpPr txBox="1">
                <a:spLocks noChangeArrowheads="1"/>
              </p:cNvSpPr>
              <p:nvPr/>
            </p:nvSpPr>
            <p:spPr bwMode="auto">
              <a:xfrm>
                <a:off x="8337124" y="1595643"/>
                <a:ext cx="707527" cy="204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IB: RIPK1</a:t>
                </a:r>
                <a:endParaRPr lang="en-GB" sz="900" dirty="0"/>
              </a:p>
            </p:txBody>
          </p:sp>
          <p:sp>
            <p:nvSpPr>
              <p:cNvPr id="121" name="TextBox 120"/>
              <p:cNvSpPr txBox="1">
                <a:spLocks noChangeArrowheads="1"/>
              </p:cNvSpPr>
              <p:nvPr/>
            </p:nvSpPr>
            <p:spPr bwMode="auto">
              <a:xfrm>
                <a:off x="8337124" y="1825549"/>
                <a:ext cx="859927" cy="204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IB: Caspase-8</a:t>
                </a:r>
                <a:endParaRPr lang="en-GB" sz="900" dirty="0"/>
              </a:p>
            </p:txBody>
          </p:sp>
        </p:grpSp>
        <p:sp>
          <p:nvSpPr>
            <p:cNvPr id="122" name="TextBox 121"/>
            <p:cNvSpPr txBox="1"/>
            <p:nvPr/>
          </p:nvSpPr>
          <p:spPr>
            <a:xfrm>
              <a:off x="4271802" y="2364538"/>
              <a:ext cx="7636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u="sng" dirty="0"/>
                <a:t>DU145</a:t>
              </a:r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3834537" y="2497210"/>
              <a:ext cx="1955531" cy="978918"/>
              <a:chOff x="331772" y="245874"/>
              <a:chExt cx="1955531" cy="978918"/>
            </a:xfrm>
          </p:grpSpPr>
          <p:sp>
            <p:nvSpPr>
              <p:cNvPr id="124" name="TextBox 123"/>
              <p:cNvSpPr txBox="1">
                <a:spLocks noChangeArrowheads="1"/>
              </p:cNvSpPr>
              <p:nvPr/>
            </p:nvSpPr>
            <p:spPr bwMode="auto">
              <a:xfrm rot="16200000">
                <a:off x="169390" y="831578"/>
                <a:ext cx="5555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Lysate</a:t>
                </a:r>
              </a:p>
            </p:txBody>
          </p:sp>
          <p:sp>
            <p:nvSpPr>
              <p:cNvPr id="125" name="TextBox 124"/>
              <p:cNvSpPr txBox="1">
                <a:spLocks noChangeArrowheads="1"/>
              </p:cNvSpPr>
              <p:nvPr/>
            </p:nvSpPr>
            <p:spPr bwMode="auto">
              <a:xfrm rot="16200000">
                <a:off x="173316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26" name="TextBox 125"/>
              <p:cNvSpPr txBox="1">
                <a:spLocks noChangeArrowheads="1"/>
              </p:cNvSpPr>
              <p:nvPr/>
            </p:nvSpPr>
            <p:spPr bwMode="auto">
              <a:xfrm rot="16200000">
                <a:off x="1105148" y="689401"/>
                <a:ext cx="8399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660</a:t>
                </a:r>
                <a:endParaRPr lang="en-GB" sz="900" dirty="0"/>
              </a:p>
            </p:txBody>
          </p:sp>
          <p:sp>
            <p:nvSpPr>
              <p:cNvPr id="127" name="TextBox 126"/>
              <p:cNvSpPr txBox="1">
                <a:spLocks noChangeArrowheads="1"/>
              </p:cNvSpPr>
              <p:nvPr/>
            </p:nvSpPr>
            <p:spPr bwMode="auto">
              <a:xfrm rot="16200000">
                <a:off x="1490374" y="643453"/>
                <a:ext cx="9318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ASTX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28" name="TextBox 127"/>
              <p:cNvSpPr txBox="1">
                <a:spLocks noChangeArrowheads="1"/>
              </p:cNvSpPr>
              <p:nvPr/>
            </p:nvSpPr>
            <p:spPr bwMode="auto">
              <a:xfrm rot="16200000">
                <a:off x="388903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29" name="TextBox 128"/>
              <p:cNvSpPr txBox="1">
                <a:spLocks noChangeArrowheads="1"/>
              </p:cNvSpPr>
              <p:nvPr/>
            </p:nvSpPr>
            <p:spPr bwMode="auto">
              <a:xfrm rot="16200000">
                <a:off x="604490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Con</a:t>
                </a:r>
                <a:endParaRPr lang="en-GB" sz="900" dirty="0"/>
              </a:p>
            </p:txBody>
          </p:sp>
          <p:sp>
            <p:nvSpPr>
              <p:cNvPr id="130" name="TextBox 129"/>
              <p:cNvSpPr txBox="1">
                <a:spLocks noChangeArrowheads="1"/>
              </p:cNvSpPr>
              <p:nvPr/>
            </p:nvSpPr>
            <p:spPr bwMode="auto">
              <a:xfrm rot="16200000">
                <a:off x="1320735" y="689401"/>
                <a:ext cx="8399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32711</a:t>
                </a:r>
                <a:endParaRPr lang="en-GB" sz="900" dirty="0"/>
              </a:p>
            </p:txBody>
          </p:sp>
          <p:sp>
            <p:nvSpPr>
              <p:cNvPr id="131" name="TextBox 130"/>
              <p:cNvSpPr txBox="1">
                <a:spLocks noChangeArrowheads="1"/>
              </p:cNvSpPr>
              <p:nvPr/>
            </p:nvSpPr>
            <p:spPr bwMode="auto">
              <a:xfrm rot="16200000">
                <a:off x="1705964" y="643453"/>
                <a:ext cx="93184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L+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  <p:sp>
            <p:nvSpPr>
              <p:cNvPr id="132" name="TextBox 131"/>
              <p:cNvSpPr txBox="1">
                <a:spLocks noChangeArrowheads="1"/>
              </p:cNvSpPr>
              <p:nvPr/>
            </p:nvSpPr>
            <p:spPr bwMode="auto">
              <a:xfrm rot="16200000">
                <a:off x="820077" y="619917"/>
                <a:ext cx="97891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GB" sz="900" b="1" dirty="0"/>
                  <a:t>TNF</a:t>
                </a:r>
                <a:r>
                  <a:rPr lang="el-GR" sz="900" b="1" dirty="0"/>
                  <a:t>α</a:t>
                </a:r>
                <a:endParaRPr lang="en-GB" sz="900" dirty="0"/>
              </a:p>
            </p:txBody>
          </p:sp>
        </p:grpSp>
        <p:cxnSp>
          <p:nvCxnSpPr>
            <p:cNvPr id="133" name="Straight Connector 132"/>
            <p:cNvCxnSpPr/>
            <p:nvPr/>
          </p:nvCxnSpPr>
          <p:spPr>
            <a:xfrm>
              <a:off x="4035242" y="2761703"/>
              <a:ext cx="399656" cy="8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>
              <a:spLocks noChangeArrowheads="1"/>
            </p:cNvSpPr>
            <p:nvPr/>
          </p:nvSpPr>
          <p:spPr bwMode="auto">
            <a:xfrm>
              <a:off x="4004340" y="2541875"/>
              <a:ext cx="510151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sz="900" b="1" dirty="0"/>
                <a:t>IP: IgG</a:t>
              </a:r>
              <a:endParaRPr lang="en-GB" sz="900" dirty="0"/>
            </a:p>
          </p:txBody>
        </p:sp>
        <p:cxnSp>
          <p:nvCxnSpPr>
            <p:cNvPr id="135" name="Straight Connector 134"/>
            <p:cNvCxnSpPr/>
            <p:nvPr/>
          </p:nvCxnSpPr>
          <p:spPr>
            <a:xfrm>
              <a:off x="4580983" y="2760880"/>
              <a:ext cx="1140266" cy="8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>
              <a:spLocks noChangeArrowheads="1"/>
            </p:cNvSpPr>
            <p:nvPr/>
          </p:nvSpPr>
          <p:spPr bwMode="auto">
            <a:xfrm>
              <a:off x="4806849" y="2541520"/>
              <a:ext cx="64658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sz="900" b="1" dirty="0"/>
                <a:t>IP: Casp8</a:t>
              </a:r>
              <a:endParaRPr lang="en-GB" sz="900" dirty="0"/>
            </a:p>
          </p:txBody>
        </p:sp>
        <p:pic>
          <p:nvPicPr>
            <p:cNvPr id="139" name="Picture 13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28376" y="3485429"/>
              <a:ext cx="1966149" cy="525266"/>
            </a:xfrm>
            <a:prstGeom prst="rect">
              <a:avLst/>
            </a:prstGeom>
          </p:spPr>
        </p:pic>
      </p:grpSp>
      <p:graphicFrame>
        <p:nvGraphicFramePr>
          <p:cNvPr id="141" name="Object 140"/>
          <p:cNvGraphicFramePr>
            <a:graphicFrameLocks noChangeAspect="1"/>
          </p:cNvGraphicFramePr>
          <p:nvPr>
            <p:extLst/>
          </p:nvPr>
        </p:nvGraphicFramePr>
        <p:xfrm>
          <a:off x="1708349" y="2516551"/>
          <a:ext cx="6219825" cy="2084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5" r:id="rId6" imgW="9107640" imgH="3051360" progId="Prism5.Document">
                  <p:embed/>
                </p:oleObj>
              </mc:Choice>
              <mc:Fallback>
                <p:oleObj name="Prism 5" r:id="rId6" imgW="9107640" imgH="3051360" progId="Prism5.Document">
                  <p:embed/>
                  <p:pic>
                    <p:nvPicPr>
                      <p:cNvPr id="141" name="Object 14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08349" y="2516551"/>
                        <a:ext cx="6219825" cy="2084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2" name="TextBox 141"/>
          <p:cNvSpPr txBox="1"/>
          <p:nvPr/>
        </p:nvSpPr>
        <p:spPr>
          <a:xfrm>
            <a:off x="1587500" y="248684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endParaRPr lang="en-GB" dirty="0"/>
          </a:p>
        </p:txBody>
      </p:sp>
      <p:sp>
        <p:nvSpPr>
          <p:cNvPr id="143" name="TextBox 142"/>
          <p:cNvSpPr txBox="1"/>
          <p:nvPr/>
        </p:nvSpPr>
        <p:spPr>
          <a:xfrm>
            <a:off x="1587500" y="52682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597195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22823" y="239737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3</a:t>
            </a:r>
            <a:endParaRPr lang="en-GB" b="1" dirty="0"/>
          </a:p>
        </p:txBody>
      </p:sp>
      <p:graphicFrame>
        <p:nvGraphicFramePr>
          <p:cNvPr id="77" name="Object 7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4892220"/>
              </p:ext>
            </p:extLst>
          </p:nvPr>
        </p:nvGraphicFramePr>
        <p:xfrm>
          <a:off x="1189368" y="2391818"/>
          <a:ext cx="9113207" cy="23284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5" name="Prism 5" r:id="rId3" imgW="9882720" imgH="2359080" progId="Prism5.Document">
                  <p:embed/>
                </p:oleObj>
              </mc:Choice>
              <mc:Fallback>
                <p:oleObj name="Prism 5" r:id="rId3" imgW="9882720" imgH="2359080" progId="Prism5.Document">
                  <p:embed/>
                  <p:pic>
                    <p:nvPicPr>
                      <p:cNvPr id="45" name="Object 4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89368" y="2391818"/>
                        <a:ext cx="9113207" cy="232848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9" name="TextBox 98"/>
          <p:cNvSpPr txBox="1"/>
          <p:nvPr/>
        </p:nvSpPr>
        <p:spPr>
          <a:xfrm>
            <a:off x="2406570" y="2391818"/>
            <a:ext cx="7636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u="sng" dirty="0" smtClean="0"/>
              <a:t>PC3</a:t>
            </a:r>
            <a:endParaRPr lang="en-GB" sz="1100" b="1" u="sng" dirty="0"/>
          </a:p>
        </p:txBody>
      </p:sp>
      <p:sp>
        <p:nvSpPr>
          <p:cNvPr id="100" name="TextBox 99"/>
          <p:cNvSpPr txBox="1"/>
          <p:nvPr/>
        </p:nvSpPr>
        <p:spPr>
          <a:xfrm>
            <a:off x="5536077" y="2391818"/>
            <a:ext cx="7636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u="sng" dirty="0" smtClean="0"/>
              <a:t>DU145</a:t>
            </a:r>
            <a:endParaRPr lang="en-GB" sz="1100" b="1" u="sng" dirty="0"/>
          </a:p>
        </p:txBody>
      </p:sp>
      <p:sp>
        <p:nvSpPr>
          <p:cNvPr id="101" name="TextBox 100"/>
          <p:cNvSpPr txBox="1"/>
          <p:nvPr/>
        </p:nvSpPr>
        <p:spPr>
          <a:xfrm>
            <a:off x="8283760" y="2391818"/>
            <a:ext cx="7636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u="sng" dirty="0" err="1" smtClean="0"/>
              <a:t>VCaP</a:t>
            </a:r>
            <a:endParaRPr lang="en-GB" sz="1100" b="1" u="sng" dirty="0"/>
          </a:p>
        </p:txBody>
      </p:sp>
    </p:spTree>
    <p:extLst>
      <p:ext uri="{BB962C8B-B14F-4D97-AF65-F5344CB8AC3E}">
        <p14:creationId xmlns:p14="http://schemas.microsoft.com/office/powerpoint/2010/main" val="3336244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534887" y="1993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4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035300" y="2586038"/>
          <a:ext cx="6337300" cy="2127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6" name="Prism 5" r:id="rId4" imgW="8141400" imgH="2732400" progId="Prism5.Document">
                  <p:embed/>
                </p:oleObj>
              </mc:Choice>
              <mc:Fallback>
                <p:oleObj name="Prism 5" r:id="rId4" imgW="8141400" imgH="273240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35300" y="2586038"/>
                        <a:ext cx="6337300" cy="2127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128963" y="398463"/>
          <a:ext cx="6094412" cy="2165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7" name="Prism 5" r:id="rId6" imgW="9078480" imgH="3101400" progId="Prism5.Document">
                  <p:embed/>
                </p:oleObj>
              </mc:Choice>
              <mc:Fallback>
                <p:oleObj name="Prism 5" r:id="rId6" imgW="9078480" imgH="3101400" progId="Prism5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28963" y="398463"/>
                        <a:ext cx="6094412" cy="2165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590800" y="237386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590800" y="41385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16478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3200400" y="762000"/>
            <a:ext cx="5264150" cy="3714750"/>
            <a:chOff x="1524000" y="2981432"/>
            <a:chExt cx="5264150" cy="3714750"/>
          </a:xfrm>
        </p:grpSpPr>
        <p:graphicFrame>
          <p:nvGraphicFramePr>
            <p:cNvPr id="6" name="Object 5"/>
            <p:cNvGraphicFramePr>
              <a:graphicFrameLocks noChangeAspect="1"/>
            </p:cNvGraphicFramePr>
            <p:nvPr>
              <p:extLst/>
            </p:nvPr>
          </p:nvGraphicFramePr>
          <p:xfrm>
            <a:off x="1524000" y="3276600"/>
            <a:ext cx="2700079" cy="17643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42" name="Prism 5" r:id="rId4" imgW="4969800" imgH="2687040" progId="Prism5.Document">
                    <p:embed/>
                  </p:oleObj>
                </mc:Choice>
                <mc:Fallback>
                  <p:oleObj name="Prism 5" r:id="rId4" imgW="4969800" imgH="2687040" progId="Prism5.Document">
                    <p:embed/>
                    <p:pic>
                      <p:nvPicPr>
                        <p:cNvPr id="6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524000" y="3276600"/>
                          <a:ext cx="2700079" cy="176431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/>
            </p:nvPr>
          </p:nvGraphicFramePr>
          <p:xfrm>
            <a:off x="1600200" y="4948738"/>
            <a:ext cx="2611551" cy="17473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43" name="Prism 5" r:id="rId6" imgW="4969800" imgH="2687040" progId="Prism5.Document">
                    <p:embed/>
                  </p:oleObj>
                </mc:Choice>
                <mc:Fallback>
                  <p:oleObj name="Prism 5" r:id="rId6" imgW="4969800" imgH="2687040" progId="Prism5.Document">
                    <p:embed/>
                    <p:pic>
                      <p:nvPicPr>
                        <p:cNvPr id="7" name="Object 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00200" y="4948738"/>
                          <a:ext cx="2611551" cy="174734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>
              <p:extLst/>
            </p:nvPr>
          </p:nvGraphicFramePr>
          <p:xfrm>
            <a:off x="4284663" y="3276707"/>
            <a:ext cx="2486025" cy="17637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44" name="Prism 5" r:id="rId8" imgW="4988160" imgH="2687040" progId="Prism5.Document">
                    <p:embed/>
                  </p:oleObj>
                </mc:Choice>
                <mc:Fallback>
                  <p:oleObj name="Prism 5" r:id="rId8" imgW="4988160" imgH="2687040" progId="Prism5.Document">
                    <p:embed/>
                    <p:pic>
                      <p:nvPicPr>
                        <p:cNvPr id="8" name="Object 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284663" y="3276707"/>
                          <a:ext cx="2486025" cy="17637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>
              <p:extLst/>
            </p:nvPr>
          </p:nvGraphicFramePr>
          <p:xfrm>
            <a:off x="4284663" y="4948345"/>
            <a:ext cx="2503487" cy="1747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45" name="Prism 5" r:id="rId10" imgW="4988160" imgH="2687040" progId="Prism5.Document">
                    <p:embed/>
                  </p:oleObj>
                </mc:Choice>
                <mc:Fallback>
                  <p:oleObj name="Prism 5" r:id="rId10" imgW="4988160" imgH="2687040" progId="Prism5.Document">
                    <p:embed/>
                    <p:pic>
                      <p:nvPicPr>
                        <p:cNvPr id="9" name="Object 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284663" y="4948345"/>
                          <a:ext cx="2503487" cy="17478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4648200" y="2981432"/>
              <a:ext cx="11206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u="sng" dirty="0"/>
                <a:t>DU145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57400" y="2981432"/>
              <a:ext cx="11206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u="sng" dirty="0"/>
                <a:t>PC3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524001" y="10180"/>
            <a:ext cx="2507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5</a:t>
            </a:r>
            <a:r>
              <a:rPr lang="en-GB" b="1" dirty="0" smtClean="0"/>
              <a:t>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839148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534887" y="52235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6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0188401"/>
              </p:ext>
            </p:extLst>
          </p:nvPr>
        </p:nvGraphicFramePr>
        <p:xfrm>
          <a:off x="3163529" y="600232"/>
          <a:ext cx="5349240" cy="18386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9" name="Prism 5" r:id="rId4" imgW="8955000" imgH="2953440" progId="Prism5.Document">
                  <p:embed/>
                </p:oleObj>
              </mc:Choice>
              <mc:Fallback>
                <p:oleObj name="Prism 5" r:id="rId4" imgW="8955000" imgH="295344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63529" y="600232"/>
                        <a:ext cx="5349240" cy="18386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2957934" y="2716460"/>
          <a:ext cx="2742045" cy="21056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0" name="Prism 5" r:id="rId6" imgW="4014000" imgH="3081600" progId="Prism5.Document">
                  <p:embed/>
                </p:oleObj>
              </mc:Choice>
              <mc:Fallback>
                <p:oleObj name="Prism 5" r:id="rId6" imgW="4014000" imgH="3081600" progId="Prism5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57934" y="2716460"/>
                        <a:ext cx="2742045" cy="21056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5726136" y="2791650"/>
          <a:ext cx="2800350" cy="2030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1" name="Prism 5" r:id="rId8" imgW="4101120" imgH="2971800" progId="Prism5.Document">
                  <p:embed/>
                </p:oleObj>
              </mc:Choice>
              <mc:Fallback>
                <p:oleObj name="Prism 5" r:id="rId8" imgW="4101120" imgH="297180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26136" y="2791650"/>
                        <a:ext cx="2800350" cy="2030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729333" y="45756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2706329" y="26670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52708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73</TotalTime>
  <Words>335</Words>
  <Application>Microsoft Office PowerPoint</Application>
  <PresentationFormat>Widescreen</PresentationFormat>
  <Paragraphs>60</Paragraphs>
  <Slides>6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GraphPad Prism 5 Project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McCann</dc:creator>
  <cp:lastModifiedBy>Christopher McCann</cp:lastModifiedBy>
  <cp:revision>17</cp:revision>
  <dcterms:created xsi:type="dcterms:W3CDTF">2018-04-20T15:59:47Z</dcterms:created>
  <dcterms:modified xsi:type="dcterms:W3CDTF">2018-09-19T13:19:58Z</dcterms:modified>
</cp:coreProperties>
</file>